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2D1B2E-700A-4D7F-A609-E4A452D330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2FA57D-605A-E228-8F71-5137732F1A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6936D0-CB74-A300-9EC3-6390A6234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94DF18-996E-B498-193B-8A445BF475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EFA975-98B7-E196-98CE-56243615D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806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9C2289-84D1-864C-C4CB-D6B9B9D3CC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8C5C72-F799-FEC0-1D9E-ED3AC8BAA6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301749-9C0E-9CE9-6C39-1D9844874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53D84-60C4-2BF2-0E49-D658C3B24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FDF5CE-CFEB-CBE3-6F54-12396DAFA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586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DC25187-BF2F-82E9-D116-97A1DAAB5A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FEAD4C-2E8E-6554-F82D-B12A360712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C41A54-E70C-E954-6B51-83EC66627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8B5EAD-20EF-D06D-1E72-3B6A924F0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5FC62A-50BD-75B9-06B1-989B44D98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110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8083E3-5B68-0FF8-452F-BDF7B0A13E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ABF846-1545-834A-1C3D-04C37ADB7F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8285A9-5666-9F3C-DC80-CDBD0F95D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0879AB-F325-7117-E1C8-87F4662DB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5B6A37-3D62-D7EF-1447-3C2461589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50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B47EB-5283-5DA6-95AC-22EB0716F7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093AB6-8AE5-A5B9-0CDA-A86351D764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35DAF0-0A1A-C585-CFDA-1EF1282AF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A0FB2C-6074-3A6D-B4D9-936DA1539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6A820A-2553-B3DF-91CD-B1BBE5426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070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07A98-9B47-8C3D-C33C-09526129DB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AC65A8-C07A-04CD-98F3-F926D1357C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8850EA-5483-5DF2-ADB1-29018DB151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4ECD4B-4AB5-0FBB-432E-925A650D4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44A916-00A9-612F-7833-5D62F1744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5FA010-D7CF-E213-8AD5-E16EDC8E6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99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DAD67-C1F4-E371-56CD-589E861080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6A7543-63F4-57EE-1100-2F08212F87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85BF10-A5EE-1667-74B9-D455D7C1A4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831032-ADCC-B2AD-4720-E4C3121AA4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4D1D96-F963-477F-C566-B7A9A3E503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59C27F-9088-DA1B-89DF-66BDBC1D8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A9A540-4435-1129-AF33-EDBEBCABE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4D8FE9-C4BE-11B8-95D9-BF258263B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27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BBC3E2-67A5-DDB8-11B6-89DABB835D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A948B0-FA74-C06E-0A72-2BC3F7EFC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7AEDB8-F916-230F-5850-D546797D6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1AA1014-286F-026E-29B2-D4A5BB4E1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809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292EA5-54C5-9457-2831-FB9B6A84C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544AD3-ECAB-C7D5-6FCC-B24605F9B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43C92A-D9D4-F96E-C145-66427EB89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376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C1179-E891-B18A-630B-964517240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7654BC-320A-C545-28E1-F17BE24D75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3A54A0-C177-F311-16C7-DD66139803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6913F8-08C1-A3FB-DF5C-857100BFB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DF3A93-1618-73B1-066A-A16D0D63D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490EBE-6041-DF31-8861-6DE7E2C12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246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011A7-A7AC-B724-89C4-B39318AA7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D06918-DC82-BDCE-9260-6CB698F678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AB1BEA-11CE-C22D-ADDE-CB8656017A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BA2125-5925-7623-1735-B7E0CA3C9A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DE2623-9288-8EDB-1531-7772D5FC1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84A781-508C-878C-1527-CA2E5E4D6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960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5AFB62-4612-1ED6-54B3-1393F8CEBA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36D30E-B7DD-A563-0C2B-C0D9A161A5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C756EA-38EB-63F4-9640-D171FDEBA2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43A19F-3EB9-4F3C-866B-78E11BE974D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00C836-8866-12D9-8C76-91F2FB377B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74BA28-089A-9D43-6D36-6A1E389DC7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5B2093-B044-4031-9B4D-E8114B656A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042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flipH="1">
            <a:off x="3212425" y="75611"/>
            <a:ext cx="42410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9 Table. Down-regulated proteins are highly expressed in the CNS, based on ARCHS4 (All RNA-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IP-seq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equencing) tissue gene set analysis.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2926964" y="911816"/>
            <a:ext cx="4878619" cy="5578066"/>
            <a:chOff x="2926964" y="911816"/>
            <a:chExt cx="4878619" cy="5578066"/>
          </a:xfrm>
        </p:grpSpPr>
        <p:grpSp>
          <p:nvGrpSpPr>
            <p:cNvPr id="14" name="Group 13"/>
            <p:cNvGrpSpPr/>
            <p:nvPr/>
          </p:nvGrpSpPr>
          <p:grpSpPr>
            <a:xfrm>
              <a:off x="3373240" y="1413196"/>
              <a:ext cx="4432343" cy="5076686"/>
              <a:chOff x="5553302" y="1413196"/>
              <a:chExt cx="4432343" cy="5076686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2"/>
              <a:srcRect l="5680" t="18666" r="9852" b="3337"/>
              <a:stretch/>
            </p:blipFill>
            <p:spPr>
              <a:xfrm>
                <a:off x="5553302" y="1996068"/>
                <a:ext cx="4432343" cy="4493814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 rot="19512370">
                <a:off x="6465345" y="1627697"/>
                <a:ext cx="9220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Brain (Bulk)</a:t>
                </a: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 rot="19512370">
                <a:off x="6729896" y="1547659"/>
                <a:ext cx="118013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erebral Cortex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 rot="19512370">
                <a:off x="7003565" y="1628154"/>
                <a:ext cx="9236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pinal Cord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9512370">
                <a:off x="7531818" y="1501466"/>
                <a:ext cx="13308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pinal Cord (Bulk)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9512370">
                <a:off x="7250293" y="1464091"/>
                <a:ext cx="1454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Breast (Bulk Tissue)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9512370">
                <a:off x="7832926" y="1542628"/>
                <a:ext cx="11961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ingulate Gyrus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9512370">
                <a:off x="8093092" y="1413196"/>
                <a:ext cx="16097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uperior Frontal Gyrus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9512370">
                <a:off x="8390960" y="1554520"/>
                <a:ext cx="115608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orsal Striatum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9512370">
                <a:off x="8652708" y="1588821"/>
                <a:ext cx="104547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otor Neuron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9512370">
                <a:off x="8938314" y="1663828"/>
                <a:ext cx="80182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mentum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 rot="10800000">
              <a:off x="2926964" y="3664443"/>
              <a:ext cx="430887" cy="130099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nput genes 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065729" y="911816"/>
              <a:ext cx="9439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issu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06577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03:45Z</dcterms:created>
  <dcterms:modified xsi:type="dcterms:W3CDTF">2025-07-28T20:04:32Z</dcterms:modified>
</cp:coreProperties>
</file>